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9"/>
  </p:notesMasterIdLst>
  <p:sldIdLst>
    <p:sldId id="257" r:id="rId2"/>
    <p:sldId id="258" r:id="rId3"/>
    <p:sldId id="266" r:id="rId4"/>
    <p:sldId id="268" r:id="rId5"/>
    <p:sldId id="264" r:id="rId6"/>
    <p:sldId id="265" r:id="rId7"/>
    <p:sldId id="260" r:id="rId8"/>
  </p:sldIdLst>
  <p:sldSz cx="6858000" cy="9906000" type="A4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667" autoAdjust="0"/>
    <p:restoredTop sz="94660"/>
  </p:normalViewPr>
  <p:slideViewPr>
    <p:cSldViewPr snapToGrid="0">
      <p:cViewPr>
        <p:scale>
          <a:sx n="400" d="100"/>
          <a:sy n="400" d="100"/>
        </p:scale>
        <p:origin x="-6052" y="-71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D9945C-C8EE-48A0-BA42-D527DFC37C38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E93C19-3C9E-4AEB-BBFF-34330E3936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3930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16150" y="1233488"/>
            <a:ext cx="2303463" cy="33289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2E841B-A1E8-6649-BBAC-03273B8D6A6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80227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8E93C19-3C9E-4AEB-BBFF-34330E39367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339594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16150" y="1233488"/>
            <a:ext cx="2303463" cy="33289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2E841B-A1E8-6649-BBAC-03273B8D6A6D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63446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1090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6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8672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1948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9945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10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1132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8518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1381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419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991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6606A-FDC7-4247-8DAE-9FC19C86E997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ABA35-3C28-4753-B3FD-A44B89CBA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891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3" Type="http://schemas.openxmlformats.org/officeDocument/2006/relationships/image" Target="../media/image12.emf"/><Relationship Id="rId7" Type="http://schemas.openxmlformats.org/officeDocument/2006/relationships/image" Target="../media/image16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tiff"/><Relationship Id="rId5" Type="http://schemas.openxmlformats.org/officeDocument/2006/relationships/image" Target="../media/image14.emf"/><Relationship Id="rId10" Type="http://schemas.openxmlformats.org/officeDocument/2006/relationships/image" Target="../media/image19.tiff"/><Relationship Id="rId4" Type="http://schemas.openxmlformats.org/officeDocument/2006/relationships/image" Target="../media/image13.emf"/><Relationship Id="rId9" Type="http://schemas.openxmlformats.org/officeDocument/2006/relationships/image" Target="../media/image18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 Box 13"/>
          <p:cNvSpPr txBox="1">
            <a:spLocks noChangeArrowheads="1"/>
          </p:cNvSpPr>
          <p:nvPr/>
        </p:nvSpPr>
        <p:spPr bwMode="auto">
          <a:xfrm>
            <a:off x="580161" y="739820"/>
            <a:ext cx="327334" cy="3481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22" name="テキスト ボックス 321"/>
          <p:cNvSpPr txBox="1"/>
          <p:nvPr/>
        </p:nvSpPr>
        <p:spPr>
          <a:xfrm>
            <a:off x="3646714" y="4071106"/>
            <a:ext cx="33855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C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330" name="テキスト ボックス 329"/>
          <p:cNvSpPr txBox="1"/>
          <p:nvPr/>
        </p:nvSpPr>
        <p:spPr>
          <a:xfrm>
            <a:off x="263769" y="381002"/>
            <a:ext cx="246093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Supplementary Figure 1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C12391F2-3164-4F4D-977F-C755CF9C33D0}"/>
              </a:ext>
            </a:extLst>
          </p:cNvPr>
          <p:cNvSpPr txBox="1"/>
          <p:nvPr/>
        </p:nvSpPr>
        <p:spPr>
          <a:xfrm>
            <a:off x="458771" y="4021575"/>
            <a:ext cx="32733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B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xmlns="" id="{A7B26BD9-E1FE-F74E-88AA-8FC0366E27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484" y="4310576"/>
            <a:ext cx="5835929" cy="2400471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xmlns="" id="{75FDFBEA-9A6C-014C-A286-7ED7942CCE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9870" y="1227891"/>
            <a:ext cx="3290243" cy="22877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08157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xmlns="" id="{36E0D1EA-4A69-BA46-B109-FB47CE199D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61291" y="4012870"/>
            <a:ext cx="2862322" cy="2191104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xmlns="" id="{54BC3A5B-454B-5B4E-B61D-8A81ABC44A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4118" y="6653458"/>
            <a:ext cx="2978445" cy="2712359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xmlns="" id="{D29C0CF9-DF58-2C43-B234-C9CBF6D792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4473" y="6647965"/>
            <a:ext cx="2978445" cy="2600775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xmlns="" id="{020D311B-B733-CF47-9EA1-057BCEAE3EF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2701"/>
          <a:stretch/>
        </p:blipFill>
        <p:spPr>
          <a:xfrm>
            <a:off x="3801075" y="1428293"/>
            <a:ext cx="2571438" cy="2068292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xmlns="" id="{406EC655-A67E-394F-BE80-4EEA075973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9663" y="3947757"/>
            <a:ext cx="3555962" cy="2189415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xmlns="" id="{9091D4E7-8242-DE43-826D-0D326C54C43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3770" y="1271218"/>
            <a:ext cx="3509312" cy="2331659"/>
          </a:xfrm>
          <a:prstGeom prst="rect">
            <a:avLst/>
          </a:prstGeom>
        </p:spPr>
      </p:pic>
      <p:sp>
        <p:nvSpPr>
          <p:cNvPr id="228" name="テキスト ボックス 227"/>
          <p:cNvSpPr txBox="1"/>
          <p:nvPr/>
        </p:nvSpPr>
        <p:spPr>
          <a:xfrm>
            <a:off x="292107" y="864891"/>
            <a:ext cx="32733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A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229" name="テキスト ボックス 228"/>
          <p:cNvSpPr txBox="1"/>
          <p:nvPr/>
        </p:nvSpPr>
        <p:spPr>
          <a:xfrm>
            <a:off x="292107" y="3599320"/>
            <a:ext cx="33855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C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230" name="テキスト ボックス 229"/>
          <p:cNvSpPr txBox="1"/>
          <p:nvPr/>
        </p:nvSpPr>
        <p:spPr>
          <a:xfrm>
            <a:off x="3845625" y="3599320"/>
            <a:ext cx="33855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D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231" name="テキスト ボックス 230"/>
          <p:cNvSpPr txBox="1"/>
          <p:nvPr/>
        </p:nvSpPr>
        <p:spPr>
          <a:xfrm>
            <a:off x="3845625" y="864891"/>
            <a:ext cx="32733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B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242" name="テキスト ボックス 241"/>
          <p:cNvSpPr txBox="1"/>
          <p:nvPr/>
        </p:nvSpPr>
        <p:spPr>
          <a:xfrm>
            <a:off x="292107" y="6424030"/>
            <a:ext cx="32733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E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243" name="テキスト ボックス 242"/>
          <p:cNvSpPr txBox="1"/>
          <p:nvPr/>
        </p:nvSpPr>
        <p:spPr>
          <a:xfrm>
            <a:off x="3845625" y="6424030"/>
            <a:ext cx="31451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F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244" name="テキスト ボックス 243"/>
          <p:cNvSpPr txBox="1"/>
          <p:nvPr/>
        </p:nvSpPr>
        <p:spPr>
          <a:xfrm>
            <a:off x="263769" y="381002"/>
            <a:ext cx="246093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Supplementary Figure 2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21255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xmlns="" id="{2F347C16-9320-1C48-909B-09490CB87C8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872" b="20044"/>
          <a:stretch/>
        </p:blipFill>
        <p:spPr>
          <a:xfrm>
            <a:off x="1673837" y="1137301"/>
            <a:ext cx="4710480" cy="2299353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xmlns="" id="{91C13638-4EE9-C141-A59D-BE07BD4D04A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872" b="20044"/>
          <a:stretch/>
        </p:blipFill>
        <p:spPr>
          <a:xfrm>
            <a:off x="1673837" y="3478736"/>
            <a:ext cx="4710480" cy="2299353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xmlns="" id="{6912D2E4-5D1A-0349-A2A1-9362C4CFCFB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872" b="20044"/>
          <a:stretch/>
        </p:blipFill>
        <p:spPr>
          <a:xfrm>
            <a:off x="1673837" y="5820171"/>
            <a:ext cx="4710480" cy="2299353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9106683F-5880-0540-92A3-C5491DFE0B25}"/>
              </a:ext>
            </a:extLst>
          </p:cNvPr>
          <p:cNvSpPr txBox="1"/>
          <p:nvPr/>
        </p:nvSpPr>
        <p:spPr>
          <a:xfrm>
            <a:off x="2052322" y="879726"/>
            <a:ext cx="1393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itchFamily="18" charset="0"/>
                <a:cs typeface="Times New Roman" pitchFamily="18" charset="0"/>
              </a:rPr>
              <a:t>GAPDH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30381E6A-3B3B-D549-A503-39DFD28B802F}"/>
              </a:ext>
            </a:extLst>
          </p:cNvPr>
          <p:cNvSpPr txBox="1"/>
          <p:nvPr/>
        </p:nvSpPr>
        <p:spPr>
          <a:xfrm>
            <a:off x="4276527" y="860302"/>
            <a:ext cx="1643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itchFamily="18" charset="0"/>
                <a:cs typeface="Times New Roman" pitchFamily="18" charset="0"/>
              </a:rPr>
              <a:t>α7nAChR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FD317C71-6F89-9948-9385-76738206E862}"/>
              </a:ext>
            </a:extLst>
          </p:cNvPr>
          <p:cNvSpPr txBox="1"/>
          <p:nvPr/>
        </p:nvSpPr>
        <p:spPr>
          <a:xfrm rot="16200000">
            <a:off x="2196249" y="8759694"/>
            <a:ext cx="15342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immature 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c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6C9F3995-3CC5-B048-A6C8-1844A753053E}"/>
              </a:ext>
            </a:extLst>
          </p:cNvPr>
          <p:cNvSpPr txBox="1"/>
          <p:nvPr/>
        </p:nvSpPr>
        <p:spPr>
          <a:xfrm rot="16200000">
            <a:off x="1522064" y="8784301"/>
            <a:ext cx="15834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immature 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p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FC4175E5-90B9-CB4C-BE93-9F8AA5212BB1}"/>
              </a:ext>
            </a:extLst>
          </p:cNvPr>
          <p:cNvSpPr txBox="1"/>
          <p:nvPr/>
        </p:nvSpPr>
        <p:spPr>
          <a:xfrm rot="16200000">
            <a:off x="1873833" y="8649058"/>
            <a:ext cx="13129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mature 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p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B8413A99-1CA0-AF45-80C6-22CD9B01859D}"/>
              </a:ext>
            </a:extLst>
          </p:cNvPr>
          <p:cNvSpPr txBox="1"/>
          <p:nvPr/>
        </p:nvSpPr>
        <p:spPr>
          <a:xfrm rot="16200000">
            <a:off x="1982260" y="8757157"/>
            <a:ext cx="152918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intestinal 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p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9104F605-011D-5F4E-A71A-5C7145427B28}"/>
              </a:ext>
            </a:extLst>
          </p:cNvPr>
          <p:cNvSpPr txBox="1"/>
          <p:nvPr/>
        </p:nvSpPr>
        <p:spPr>
          <a:xfrm rot="16200000">
            <a:off x="2528071" y="8644398"/>
            <a:ext cx="13036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mature 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c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B853A921-3481-8648-9881-E00E950407F1}"/>
              </a:ext>
            </a:extLst>
          </p:cNvPr>
          <p:cNvSpPr txBox="1"/>
          <p:nvPr/>
        </p:nvSpPr>
        <p:spPr>
          <a:xfrm rot="16200000">
            <a:off x="2639679" y="8749316"/>
            <a:ext cx="15135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intestinal </a:t>
            </a:r>
            <a:r>
              <a:rPr lang="en-US" altLang="ja-JP" sz="1050" b="1" dirty="0" err="1">
                <a:latin typeface="Times New Roman" pitchFamily="18" charset="0"/>
                <a:cs typeface="Times New Roman" pitchFamily="18" charset="0"/>
              </a:rPr>
              <a:t>c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B580AD83-FE2A-F94B-B95C-BC17A66632C1}"/>
              </a:ext>
            </a:extLst>
          </p:cNvPr>
          <p:cNvSpPr txBox="1"/>
          <p:nvPr/>
        </p:nvSpPr>
        <p:spPr>
          <a:xfrm rot="16200000">
            <a:off x="3259030" y="8346494"/>
            <a:ext cx="7078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Brain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7B76FB83-BD6A-DC4F-B764-A9A9DCB48957}"/>
              </a:ext>
            </a:extLst>
          </p:cNvPr>
          <p:cNvSpPr txBox="1"/>
          <p:nvPr/>
        </p:nvSpPr>
        <p:spPr>
          <a:xfrm rot="16200000">
            <a:off x="1305538" y="8784301"/>
            <a:ext cx="15834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Marker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328326FF-C147-4443-B786-BB9F4B5D36E2}"/>
              </a:ext>
            </a:extLst>
          </p:cNvPr>
          <p:cNvSpPr txBox="1"/>
          <p:nvPr/>
        </p:nvSpPr>
        <p:spPr>
          <a:xfrm rot="16200000">
            <a:off x="4398762" y="8759694"/>
            <a:ext cx="15342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immature 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c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F2517CA5-3E28-A440-A3FF-78A945D370AC}"/>
              </a:ext>
            </a:extLst>
          </p:cNvPr>
          <p:cNvSpPr txBox="1"/>
          <p:nvPr/>
        </p:nvSpPr>
        <p:spPr>
          <a:xfrm rot="16200000">
            <a:off x="3724577" y="8784301"/>
            <a:ext cx="15834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immature 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p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7FF21250-C4B1-0648-9AF4-885A23C6FE78}"/>
              </a:ext>
            </a:extLst>
          </p:cNvPr>
          <p:cNvSpPr txBox="1"/>
          <p:nvPr/>
        </p:nvSpPr>
        <p:spPr>
          <a:xfrm rot="16200000">
            <a:off x="4076346" y="8649058"/>
            <a:ext cx="13129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mature 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p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416AEC41-90B0-884D-8CB0-C6E16952C7F4}"/>
              </a:ext>
            </a:extLst>
          </p:cNvPr>
          <p:cNvSpPr txBox="1"/>
          <p:nvPr/>
        </p:nvSpPr>
        <p:spPr>
          <a:xfrm rot="16200000">
            <a:off x="4184773" y="8757157"/>
            <a:ext cx="152918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intestinal 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p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27BD0990-EABA-C844-A4CF-39C8E0D9DF27}"/>
              </a:ext>
            </a:extLst>
          </p:cNvPr>
          <p:cNvSpPr txBox="1"/>
          <p:nvPr/>
        </p:nvSpPr>
        <p:spPr>
          <a:xfrm rot="16200000">
            <a:off x="4730584" y="8644398"/>
            <a:ext cx="13036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mature 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c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C08A9DA1-6F89-3C4E-8C84-540751EF628D}"/>
              </a:ext>
            </a:extLst>
          </p:cNvPr>
          <p:cNvSpPr txBox="1"/>
          <p:nvPr/>
        </p:nvSpPr>
        <p:spPr>
          <a:xfrm rot="16200000">
            <a:off x="4842192" y="8749316"/>
            <a:ext cx="15135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intestinal </a:t>
            </a:r>
            <a:r>
              <a:rPr lang="en-US" altLang="ja-JP" sz="1050" b="1" dirty="0" err="1">
                <a:latin typeface="Times New Roman" pitchFamily="18" charset="0"/>
                <a:cs typeface="Times New Roman" pitchFamily="18" charset="0"/>
              </a:rPr>
              <a:t>c</a:t>
            </a:r>
            <a:r>
              <a:rPr kumimoji="1" lang="en-US" altLang="ja-JP" sz="1050" b="1" dirty="0" err="1">
                <a:latin typeface="Times New Roman" pitchFamily="18" charset="0"/>
                <a:cs typeface="Times New Roman" pitchFamily="18" charset="0"/>
              </a:rPr>
              <a:t>DC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995431A9-DEA2-F642-BF15-4FC299830EB0}"/>
              </a:ext>
            </a:extLst>
          </p:cNvPr>
          <p:cNvSpPr txBox="1"/>
          <p:nvPr/>
        </p:nvSpPr>
        <p:spPr>
          <a:xfrm rot="16200000">
            <a:off x="5461543" y="8346494"/>
            <a:ext cx="7078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Brain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60D2CFA9-5594-3646-9625-8ADB197C75D9}"/>
              </a:ext>
            </a:extLst>
          </p:cNvPr>
          <p:cNvSpPr txBox="1"/>
          <p:nvPr/>
        </p:nvSpPr>
        <p:spPr>
          <a:xfrm rot="16200000">
            <a:off x="3508051" y="8784301"/>
            <a:ext cx="15834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b="1" dirty="0">
                <a:latin typeface="Times New Roman" pitchFamily="18" charset="0"/>
                <a:cs typeface="Times New Roman" pitchFamily="18" charset="0"/>
              </a:rPr>
              <a:t>Marker</a:t>
            </a:r>
            <a:endParaRPr kumimoji="1" lang="ja-JP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xmlns="" id="{851902EC-566B-B046-9728-752D85FC35FC}"/>
              </a:ext>
            </a:extLst>
          </p:cNvPr>
          <p:cNvSpPr txBox="1"/>
          <p:nvPr/>
        </p:nvSpPr>
        <p:spPr>
          <a:xfrm>
            <a:off x="73398" y="1157904"/>
            <a:ext cx="16033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nger exposure </a:t>
            </a:r>
            <a:r>
              <a:rPr lang="en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me 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xmlns="" id="{91F6B2B4-A76A-3F4E-8BDE-A971937B14AC}"/>
              </a:ext>
            </a:extLst>
          </p:cNvPr>
          <p:cNvSpPr txBox="1"/>
          <p:nvPr/>
        </p:nvSpPr>
        <p:spPr>
          <a:xfrm>
            <a:off x="73398" y="5867246"/>
            <a:ext cx="1521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rter exposure tim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63769" y="381002"/>
            <a:ext cx="246093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 smtClean="0">
                <a:latin typeface="Helvetica" pitchFamily="2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Figure 3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851902EC-566B-B046-9728-752D85FC35FC}"/>
              </a:ext>
            </a:extLst>
          </p:cNvPr>
          <p:cNvSpPr txBox="1"/>
          <p:nvPr/>
        </p:nvSpPr>
        <p:spPr>
          <a:xfrm>
            <a:off x="73398" y="3526877"/>
            <a:ext cx="16033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nger exposure </a:t>
            </a:r>
            <a:r>
              <a:rPr lang="en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me 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91281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>
            <a:extLst>
              <a:ext uri="{FF2B5EF4-FFF2-40B4-BE49-F238E27FC236}">
                <a16:creationId xmlns:a16="http://schemas.microsoft.com/office/drawing/2014/main" xmlns="" id="{2A870C8A-F755-0942-B2C9-790A8F40FE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858" y="6286913"/>
            <a:ext cx="6260123" cy="27432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xmlns="" id="{280FD297-8200-954F-A896-35DE3CFF73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2478" y="1036109"/>
            <a:ext cx="5931877" cy="2286000"/>
          </a:xfrm>
          <a:prstGeom prst="rect">
            <a:avLst/>
          </a:prstGeom>
        </p:spPr>
      </p:pic>
      <p:sp>
        <p:nvSpPr>
          <p:cNvPr id="38" name="テキスト ボックス 37"/>
          <p:cNvSpPr txBox="1"/>
          <p:nvPr/>
        </p:nvSpPr>
        <p:spPr>
          <a:xfrm>
            <a:off x="292107" y="864891"/>
            <a:ext cx="32733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A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284074" y="3131657"/>
            <a:ext cx="32733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B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263769" y="381002"/>
            <a:ext cx="246093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Supplementary Figure 4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00211" y="5819106"/>
            <a:ext cx="33855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C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451235" y="5819106"/>
            <a:ext cx="33855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D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xmlns="" id="{7CD987FD-C748-C64C-BF70-897C6294E64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3868" y="4322000"/>
            <a:ext cx="6120000" cy="1280380"/>
          </a:xfrm>
          <a:prstGeom prst="rect">
            <a:avLst/>
          </a:prstGeom>
        </p:spPr>
      </p:pic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xmlns="" id="{5CBD82F4-7CD3-497C-9D60-9479F314F2D9}"/>
              </a:ext>
            </a:extLst>
          </p:cNvPr>
          <p:cNvGrpSpPr/>
          <p:nvPr/>
        </p:nvGrpSpPr>
        <p:grpSpPr>
          <a:xfrm>
            <a:off x="673657" y="3556190"/>
            <a:ext cx="5868424" cy="1234380"/>
            <a:chOff x="54187" y="1176180"/>
            <a:chExt cx="6519427" cy="1370593"/>
          </a:xfrm>
        </p:grpSpPr>
        <p:pic>
          <p:nvPicPr>
            <p:cNvPr id="21" name="図 20">
              <a:extLst>
                <a:ext uri="{FF2B5EF4-FFF2-40B4-BE49-F238E27FC236}">
                  <a16:creationId xmlns:a16="http://schemas.microsoft.com/office/drawing/2014/main" xmlns="" id="{10E8FC29-1AA7-4FEA-BBCD-A31737014C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368123" y="1176180"/>
              <a:ext cx="1263682" cy="1370593"/>
            </a:xfrm>
            <a:prstGeom prst="rect">
              <a:avLst/>
            </a:prstGeom>
          </p:spPr>
        </p:pic>
        <p:pic>
          <p:nvPicPr>
            <p:cNvPr id="22" name="図 21">
              <a:extLst>
                <a:ext uri="{FF2B5EF4-FFF2-40B4-BE49-F238E27FC236}">
                  <a16:creationId xmlns:a16="http://schemas.microsoft.com/office/drawing/2014/main" xmlns="" id="{46E13B76-CBA2-4335-996A-0F758FBDA4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187" y="1176180"/>
              <a:ext cx="1263682" cy="1370593"/>
            </a:xfrm>
            <a:prstGeom prst="rect">
              <a:avLst/>
            </a:prstGeom>
          </p:spPr>
        </p:pic>
        <p:pic>
          <p:nvPicPr>
            <p:cNvPr id="23" name="図 22">
              <a:extLst>
                <a:ext uri="{FF2B5EF4-FFF2-40B4-BE49-F238E27FC236}">
                  <a16:creationId xmlns:a16="http://schemas.microsoft.com/office/drawing/2014/main" xmlns="" id="{3B335994-97B3-4362-8DDC-5DB503D09B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682059" y="1176180"/>
              <a:ext cx="1263682" cy="1370593"/>
            </a:xfrm>
            <a:prstGeom prst="rect">
              <a:avLst/>
            </a:prstGeom>
          </p:spPr>
        </p:pic>
        <p:pic>
          <p:nvPicPr>
            <p:cNvPr id="24" name="図 23">
              <a:extLst>
                <a:ext uri="{FF2B5EF4-FFF2-40B4-BE49-F238E27FC236}">
                  <a16:creationId xmlns:a16="http://schemas.microsoft.com/office/drawing/2014/main" xmlns="" id="{836A7669-84F6-4628-A64D-B0CF2C8244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95995" y="1176180"/>
              <a:ext cx="1263682" cy="1370593"/>
            </a:xfrm>
            <a:prstGeom prst="rect">
              <a:avLst/>
            </a:prstGeom>
          </p:spPr>
        </p:pic>
        <p:pic>
          <p:nvPicPr>
            <p:cNvPr id="25" name="図 24">
              <a:extLst>
                <a:ext uri="{FF2B5EF4-FFF2-40B4-BE49-F238E27FC236}">
                  <a16:creationId xmlns:a16="http://schemas.microsoft.com/office/drawing/2014/main" xmlns="" id="{35D0E55B-E315-4BB3-920D-EA3A1480D3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09932" y="1176180"/>
              <a:ext cx="1263682" cy="137059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553899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A3C949EA-F03E-E44F-9C30-ED232B17C0AC}"/>
              </a:ext>
            </a:extLst>
          </p:cNvPr>
          <p:cNvSpPr txBox="1"/>
          <p:nvPr/>
        </p:nvSpPr>
        <p:spPr>
          <a:xfrm>
            <a:off x="0" y="0"/>
            <a:ext cx="185820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3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lang="ja-JP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xmlns="" id="{A8BD8658-2877-A94F-BD48-DED7A28F4A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2397" y="313792"/>
            <a:ext cx="4563905" cy="9592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2290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052DC353-C201-1D42-8A3F-35BD43B293EA}"/>
              </a:ext>
            </a:extLst>
          </p:cNvPr>
          <p:cNvSpPr txBox="1"/>
          <p:nvPr/>
        </p:nvSpPr>
        <p:spPr>
          <a:xfrm>
            <a:off x="0" y="2997"/>
            <a:ext cx="185820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3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</a:t>
            </a:r>
            <a:endParaRPr lang="ja-JP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="" xmlns:a16="http://schemas.microsoft.com/office/drawing/2014/main" id="{E9A1CDCA-1BC4-684A-B59F-477C81383D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7571" y="262482"/>
            <a:ext cx="5084465" cy="96435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19613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図 19">
            <a:extLst>
              <a:ext uri="{FF2B5EF4-FFF2-40B4-BE49-F238E27FC236}">
                <a16:creationId xmlns:a16="http://schemas.microsoft.com/office/drawing/2014/main" xmlns="" id="{35887A2C-C905-7647-BCB9-1D2D4DF8CE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252" y="856963"/>
            <a:ext cx="3264833" cy="2838985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384604" y="464164"/>
            <a:ext cx="246093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62" dirty="0">
                <a:latin typeface="Helvetica" pitchFamily="2" charset="0"/>
                <a:cs typeface="Times New Roman" panose="02020603050405020304" pitchFamily="18" charset="0"/>
              </a:rPr>
              <a:t>Supplementary Figure 7</a:t>
            </a:r>
            <a:endParaRPr lang="ja-JP" altLang="en-US" sz="1662" dirty="0">
              <a:latin typeface="Helvetica" pitchFamily="2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xmlns="" id="{0905F679-5500-AA4F-891B-32A16A1877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3769" y="3747825"/>
            <a:ext cx="6330462" cy="3446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48168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12</TotalTime>
  <Words>78</Words>
  <Application>Microsoft Office PowerPoint</Application>
  <PresentationFormat>A4 210 x 297 mm</PresentationFormat>
  <Paragraphs>44</Paragraphs>
  <Slides>7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4" baseType="lpstr">
      <vt:lpstr>ＭＳ Ｐゴシック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dowaki Makoto</dc:creator>
  <cp:lastModifiedBy>Kadowaki Makoto</cp:lastModifiedBy>
  <cp:revision>15</cp:revision>
  <cp:lastPrinted>2021-04-30T11:45:35Z</cp:lastPrinted>
  <dcterms:created xsi:type="dcterms:W3CDTF">2021-04-29T07:16:17Z</dcterms:created>
  <dcterms:modified xsi:type="dcterms:W3CDTF">2021-09-15T09:18:01Z</dcterms:modified>
</cp:coreProperties>
</file>